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801350" cy="7200900"/>
  <p:notesSz cx="6858000" cy="9144000"/>
  <p:defaultTextStyle>
    <a:defPPr>
      <a:defRPr lang="zh-CN"/>
    </a:defPPr>
    <a:lvl1pPr marL="0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617153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234305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1851458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2468609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3085760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3702912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4320065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4937217" algn="l" defTabSz="1234305" rtl="0" eaLnBrk="1" latinLnBrk="0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60" y="-84"/>
      </p:cViewPr>
      <p:guideLst>
        <p:guide orient="horz" pos="2268"/>
        <p:guide pos="340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10102" y="2236950"/>
            <a:ext cx="9181148" cy="154352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620210" y="4080510"/>
            <a:ext cx="7560945" cy="1840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171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343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514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686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85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7029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3200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9372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830980" y="288374"/>
            <a:ext cx="2430304" cy="6144101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540075" y="288374"/>
            <a:ext cx="7110889" cy="6144101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53233" y="4627250"/>
            <a:ext cx="9181148" cy="1430179"/>
          </a:xfrm>
        </p:spPr>
        <p:txBody>
          <a:bodyPr anchor="t"/>
          <a:lstStyle>
            <a:lvl1pPr algn="l">
              <a:defRPr sz="54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53233" y="3052053"/>
            <a:ext cx="9181148" cy="1575197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17153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34305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85145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46860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08576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70291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32006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93721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540069" y="1680214"/>
            <a:ext cx="4770596" cy="4752261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90686" y="1680214"/>
            <a:ext cx="4770596" cy="4752261"/>
          </a:xfrm>
        </p:spPr>
        <p:txBody>
          <a:bodyPr/>
          <a:lstStyle>
            <a:lvl1pPr>
              <a:defRPr sz="3800"/>
            </a:lvl1pPr>
            <a:lvl2pPr>
              <a:defRPr sz="32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68" y="1611872"/>
            <a:ext cx="4772472" cy="67175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7153" indent="0">
              <a:buNone/>
              <a:defRPr sz="2700" b="1"/>
            </a:lvl2pPr>
            <a:lvl3pPr marL="1234305" indent="0">
              <a:buNone/>
              <a:defRPr sz="2400" b="1"/>
            </a:lvl3pPr>
            <a:lvl4pPr marL="1851458" indent="0">
              <a:buNone/>
              <a:defRPr sz="2200" b="1"/>
            </a:lvl4pPr>
            <a:lvl5pPr marL="2468609" indent="0">
              <a:buNone/>
              <a:defRPr sz="2200" b="1"/>
            </a:lvl5pPr>
            <a:lvl6pPr marL="3085760" indent="0">
              <a:buNone/>
              <a:defRPr sz="2200" b="1"/>
            </a:lvl6pPr>
            <a:lvl7pPr marL="3702912" indent="0">
              <a:buNone/>
              <a:defRPr sz="2200" b="1"/>
            </a:lvl7pPr>
            <a:lvl8pPr marL="4320065" indent="0">
              <a:buNone/>
              <a:defRPr sz="2200" b="1"/>
            </a:lvl8pPr>
            <a:lvl9pPr marL="4937217" indent="0">
              <a:buNone/>
              <a:defRPr sz="2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40068" y="2283623"/>
            <a:ext cx="4772472" cy="414885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486944" y="1611872"/>
            <a:ext cx="4774347" cy="671750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17153" indent="0">
              <a:buNone/>
              <a:defRPr sz="2700" b="1"/>
            </a:lvl2pPr>
            <a:lvl3pPr marL="1234305" indent="0">
              <a:buNone/>
              <a:defRPr sz="2400" b="1"/>
            </a:lvl3pPr>
            <a:lvl4pPr marL="1851458" indent="0">
              <a:buNone/>
              <a:defRPr sz="2200" b="1"/>
            </a:lvl4pPr>
            <a:lvl5pPr marL="2468609" indent="0">
              <a:buNone/>
              <a:defRPr sz="2200" b="1"/>
            </a:lvl5pPr>
            <a:lvl6pPr marL="3085760" indent="0">
              <a:buNone/>
              <a:defRPr sz="2200" b="1"/>
            </a:lvl6pPr>
            <a:lvl7pPr marL="3702912" indent="0">
              <a:buNone/>
              <a:defRPr sz="2200" b="1"/>
            </a:lvl7pPr>
            <a:lvl8pPr marL="4320065" indent="0">
              <a:buNone/>
              <a:defRPr sz="2200" b="1"/>
            </a:lvl8pPr>
            <a:lvl9pPr marL="4937217" indent="0">
              <a:buNone/>
              <a:defRPr sz="2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486944" y="2283623"/>
            <a:ext cx="4774347" cy="4148853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0070" y="286707"/>
            <a:ext cx="3553570" cy="1220153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223034" y="286704"/>
            <a:ext cx="6038255" cy="6145770"/>
          </a:xfrm>
        </p:spPr>
        <p:txBody>
          <a:bodyPr/>
          <a:lstStyle>
            <a:lvl1pPr>
              <a:defRPr sz="4300"/>
            </a:lvl1pPr>
            <a:lvl2pPr>
              <a:defRPr sz="3800"/>
            </a:lvl2pPr>
            <a:lvl3pPr>
              <a:defRPr sz="32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540070" y="1506858"/>
            <a:ext cx="3553570" cy="4925616"/>
          </a:xfrm>
        </p:spPr>
        <p:txBody>
          <a:bodyPr/>
          <a:lstStyle>
            <a:lvl1pPr marL="0" indent="0">
              <a:buNone/>
              <a:defRPr sz="1900"/>
            </a:lvl1pPr>
            <a:lvl2pPr marL="617153" indent="0">
              <a:buNone/>
              <a:defRPr sz="1600"/>
            </a:lvl2pPr>
            <a:lvl3pPr marL="1234305" indent="0">
              <a:buNone/>
              <a:defRPr sz="1400"/>
            </a:lvl3pPr>
            <a:lvl4pPr marL="1851458" indent="0">
              <a:buNone/>
              <a:defRPr sz="1200"/>
            </a:lvl4pPr>
            <a:lvl5pPr marL="2468609" indent="0">
              <a:buNone/>
              <a:defRPr sz="1200"/>
            </a:lvl5pPr>
            <a:lvl6pPr marL="3085760" indent="0">
              <a:buNone/>
              <a:defRPr sz="1200"/>
            </a:lvl6pPr>
            <a:lvl7pPr marL="3702912" indent="0">
              <a:buNone/>
              <a:defRPr sz="1200"/>
            </a:lvl7pPr>
            <a:lvl8pPr marL="4320065" indent="0">
              <a:buNone/>
              <a:defRPr sz="1200"/>
            </a:lvl8pPr>
            <a:lvl9pPr marL="4937217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117140" y="5040632"/>
            <a:ext cx="6480810" cy="595075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117140" y="643414"/>
            <a:ext cx="6480810" cy="4320540"/>
          </a:xfrm>
        </p:spPr>
        <p:txBody>
          <a:bodyPr/>
          <a:lstStyle>
            <a:lvl1pPr marL="0" indent="0">
              <a:buNone/>
              <a:defRPr sz="4300"/>
            </a:lvl1pPr>
            <a:lvl2pPr marL="617153" indent="0">
              <a:buNone/>
              <a:defRPr sz="3800"/>
            </a:lvl2pPr>
            <a:lvl3pPr marL="1234305" indent="0">
              <a:buNone/>
              <a:defRPr sz="3200"/>
            </a:lvl3pPr>
            <a:lvl4pPr marL="1851458" indent="0">
              <a:buNone/>
              <a:defRPr sz="2700"/>
            </a:lvl4pPr>
            <a:lvl5pPr marL="2468609" indent="0">
              <a:buNone/>
              <a:defRPr sz="2700"/>
            </a:lvl5pPr>
            <a:lvl6pPr marL="3085760" indent="0">
              <a:buNone/>
              <a:defRPr sz="2700"/>
            </a:lvl6pPr>
            <a:lvl7pPr marL="3702912" indent="0">
              <a:buNone/>
              <a:defRPr sz="2700"/>
            </a:lvl7pPr>
            <a:lvl8pPr marL="4320065" indent="0">
              <a:buNone/>
              <a:defRPr sz="2700"/>
            </a:lvl8pPr>
            <a:lvl9pPr marL="4937217" indent="0">
              <a:buNone/>
              <a:defRPr sz="27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117140" y="5635707"/>
            <a:ext cx="6480810" cy="845105"/>
          </a:xfrm>
        </p:spPr>
        <p:txBody>
          <a:bodyPr/>
          <a:lstStyle>
            <a:lvl1pPr marL="0" indent="0">
              <a:buNone/>
              <a:defRPr sz="1900"/>
            </a:lvl1pPr>
            <a:lvl2pPr marL="617153" indent="0">
              <a:buNone/>
              <a:defRPr sz="1600"/>
            </a:lvl2pPr>
            <a:lvl3pPr marL="1234305" indent="0">
              <a:buNone/>
              <a:defRPr sz="1400"/>
            </a:lvl3pPr>
            <a:lvl4pPr marL="1851458" indent="0">
              <a:buNone/>
              <a:defRPr sz="1200"/>
            </a:lvl4pPr>
            <a:lvl5pPr marL="2468609" indent="0">
              <a:buNone/>
              <a:defRPr sz="1200"/>
            </a:lvl5pPr>
            <a:lvl6pPr marL="3085760" indent="0">
              <a:buNone/>
              <a:defRPr sz="1200"/>
            </a:lvl6pPr>
            <a:lvl7pPr marL="3702912" indent="0">
              <a:buNone/>
              <a:defRPr sz="1200"/>
            </a:lvl7pPr>
            <a:lvl8pPr marL="4320065" indent="0">
              <a:buNone/>
              <a:defRPr sz="1200"/>
            </a:lvl8pPr>
            <a:lvl9pPr marL="4937217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540075" y="288370"/>
            <a:ext cx="9721215" cy="1200150"/>
          </a:xfrm>
          <a:prstGeom prst="rect">
            <a:avLst/>
          </a:prstGeom>
        </p:spPr>
        <p:txBody>
          <a:bodyPr vert="horz" lIns="123431" tIns="61715" rIns="123431" bIns="61715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0075" y="1680214"/>
            <a:ext cx="9721215" cy="4752261"/>
          </a:xfrm>
          <a:prstGeom prst="rect">
            <a:avLst/>
          </a:prstGeom>
        </p:spPr>
        <p:txBody>
          <a:bodyPr vert="horz" lIns="123431" tIns="61715" rIns="123431" bIns="61715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540075" y="6674172"/>
            <a:ext cx="2520315" cy="383381"/>
          </a:xfrm>
          <a:prstGeom prst="rect">
            <a:avLst/>
          </a:prstGeom>
        </p:spPr>
        <p:txBody>
          <a:bodyPr vert="horz" lIns="123431" tIns="61715" rIns="123431" bIns="61715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8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690462" y="6674172"/>
            <a:ext cx="3420428" cy="383381"/>
          </a:xfrm>
          <a:prstGeom prst="rect">
            <a:avLst/>
          </a:prstGeom>
        </p:spPr>
        <p:txBody>
          <a:bodyPr vert="horz" lIns="123431" tIns="61715" rIns="123431" bIns="61715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740975" y="6674172"/>
            <a:ext cx="2520315" cy="383381"/>
          </a:xfrm>
          <a:prstGeom prst="rect">
            <a:avLst/>
          </a:prstGeom>
        </p:spPr>
        <p:txBody>
          <a:bodyPr vert="horz" lIns="123431" tIns="61715" rIns="123431" bIns="61715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34305" rtl="0" eaLnBrk="1" latinLnBrk="0" hangingPunct="1">
        <a:spcBef>
          <a:spcPct val="0"/>
        </a:spcBef>
        <a:buNone/>
        <a:defRPr sz="5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2864" indent="-462864" algn="l" defTabSz="1234305" rtl="0" eaLnBrk="1" latinLnBrk="0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1pPr>
      <a:lvl2pPr marL="1002872" indent="-385719" algn="l" defTabSz="1234305" rtl="0" eaLnBrk="1" latinLnBrk="0" hangingPunct="1">
        <a:spcBef>
          <a:spcPct val="20000"/>
        </a:spcBef>
        <a:buFont typeface="Arial" pitchFamily="34" charset="0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2pPr>
      <a:lvl3pPr marL="1542880" indent="-308575" algn="l" defTabSz="1234305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60032" indent="-308575" algn="l" defTabSz="1234305" rtl="0" eaLnBrk="1" latinLnBrk="0" hangingPunct="1">
        <a:spcBef>
          <a:spcPct val="20000"/>
        </a:spcBef>
        <a:buFont typeface="Arial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77185" indent="-308575" algn="l" defTabSz="1234305" rtl="0" eaLnBrk="1" latinLnBrk="0" hangingPunct="1">
        <a:spcBef>
          <a:spcPct val="20000"/>
        </a:spcBef>
        <a:buFont typeface="Arial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394337" indent="-308575" algn="l" defTabSz="1234305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011490" indent="-308575" algn="l" defTabSz="1234305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628641" indent="-308575" algn="l" defTabSz="1234305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245792" indent="-308575" algn="l" defTabSz="1234305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17153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34305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51458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68609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85760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702912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065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937217" algn="l" defTabSz="123430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png"/><Relationship Id="rId3" Type="http://schemas.openxmlformats.org/officeDocument/2006/relationships/image" Target="../media/image2.jpeg"/><Relationship Id="rId21" Type="http://schemas.openxmlformats.org/officeDocument/2006/relationships/image" Target="../media/image19.tiff"/><Relationship Id="rId7" Type="http://schemas.openxmlformats.org/officeDocument/2006/relationships/image" Target="../media/image6.jpeg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2.tiff"/><Relationship Id="rId2" Type="http://schemas.openxmlformats.org/officeDocument/2006/relationships/image" Target="../media/image1.jpeg"/><Relationship Id="rId16" Type="http://schemas.openxmlformats.org/officeDocument/2006/relationships/image" Target="../media/image15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tiff"/><Relationship Id="rId24" Type="http://schemas.microsoft.com/office/2007/relationships/hdphoto" Target="../media/hdphoto2.wdp"/><Relationship Id="rId5" Type="http://schemas.openxmlformats.org/officeDocument/2006/relationships/image" Target="../media/image4.jpeg"/><Relationship Id="rId15" Type="http://schemas.openxmlformats.org/officeDocument/2006/relationships/image" Target="../media/image14.tiff"/><Relationship Id="rId23" Type="http://schemas.openxmlformats.org/officeDocument/2006/relationships/image" Target="../media/image21.png"/><Relationship Id="rId10" Type="http://schemas.openxmlformats.org/officeDocument/2006/relationships/image" Target="../media/image9.tiff"/><Relationship Id="rId19" Type="http://schemas.microsoft.com/office/2007/relationships/hdphoto" Target="../media/hdphoto1.wdp"/><Relationship Id="rId4" Type="http://schemas.openxmlformats.org/officeDocument/2006/relationships/image" Target="../media/image3.jpeg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矩形 18"/>
          <p:cNvSpPr/>
          <p:nvPr/>
        </p:nvSpPr>
        <p:spPr>
          <a:xfrm>
            <a:off x="42258" y="183700"/>
            <a:ext cx="3221625" cy="493967"/>
          </a:xfrm>
          <a:prstGeom prst="rect">
            <a:avLst/>
          </a:prstGeom>
        </p:spPr>
        <p:txBody>
          <a:bodyPr wrap="none" lIns="123431" tIns="61715" rIns="123431" bIns="61715">
            <a:spAutoFit/>
          </a:bodyPr>
          <a:lstStyle/>
          <a:p>
            <a:r>
              <a:rPr lang="en-US" altLang="zh-CN" smtClean="0"/>
              <a:t>Supplementary Figure 1</a:t>
            </a:r>
            <a:endParaRPr lang="zh-CN" altLang="en-US" dirty="0"/>
          </a:p>
        </p:txBody>
      </p:sp>
      <p:pic>
        <p:nvPicPr>
          <p:cNvPr id="21" name="Picture 7" descr="E:\工作\急性肾损伤\paper\LH\2022-6-5投稿\Frontiers in immunology\raw data\raw data\supplementary data\ARG1+FIZZ1\ARG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4495" y="1339130"/>
            <a:ext cx="1788791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75" y="893738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31" name="TextBox 30"/>
          <p:cNvSpPr txBox="1"/>
          <p:nvPr/>
        </p:nvSpPr>
        <p:spPr>
          <a:xfrm>
            <a:off x="7200875" y="806660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3672487" y="864146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52915" y="3744466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pic>
        <p:nvPicPr>
          <p:cNvPr id="1026" name="Picture 2" descr="E:\工作\急性肾损伤\paper\LH\2022-6-5投稿\Frontiers in immunology\raw data\raw data\supplementary data\BUN+CR\BUN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83" y="1368362"/>
            <a:ext cx="1844183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8" descr="E:\工作\急性肾损伤\paper\LH\2022-6-5投稿\Frontiers in immunology\raw data\raw data\supplementary data\BUN+CR\CR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3559" y="1368362"/>
            <a:ext cx="191778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6" descr="E:\工作\急性肾损伤\paper\LH\2022-6-5投稿\Frontiers in immunology\raw data\raw data\supplementary data\ARG1+FIZZ1\FIZZ1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44033" y="1325811"/>
            <a:ext cx="1856842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11" descr="E:\工作\急性肾损伤\paper\LH\2022-6-5投稿\Frontiers in immunology\raw data\raw data\supplementary data\TNF-a+IL-6\TNFa PCR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9857" y="1296354"/>
            <a:ext cx="1847162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10" descr="E:\工作\急性肾损伤\paper\LH\2022-6-5投稿\Frontiers in immunology\raw data\raw data\supplementary data\TNF-a+IL-6\IL-6 PCR.jp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97825" y="1296354"/>
            <a:ext cx="1803450" cy="14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2" descr="C:\Users\Administrator\Desktop\2022省自然\Image 5-use-FIM\Image 5-use-FIM_c1.tif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865" y="4579070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3" descr="C:\Users\Administrator\Desktop\2022省自然\Image 5-use-FIM\Image 5-use-FIM_c1+2+3.tif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4148" y="4579070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4" descr="C:\Users\Administrator\Desktop\2022省自然\Image 5-use-FIM\Image 5-use-FIM_c2.tif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4707" y="4579070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5" descr="C:\Users\Administrator\Desktop\2022省自然\Image 5-use-FIM\Image 5-use-FIM_c3.tif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8996" y="4579070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6" descr="C:\Users\Administrator\Desktop\2022省自然\Image 3\Image 3_c3.tif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8996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C:\Users\Administrator\Desktop\2022省自然\Image 3\Image 3_c1.tif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4707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8" descr="C:\Users\Administrator\Desktop\2022省自然\Image 3\Image 3_c1+2+3.tif"/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4148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9" descr="C:\Users\Administrator\Desktop\2022省自然\Image 3\Image 3_c2.tif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865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/>
          <p:cNvSpPr txBox="1"/>
          <p:nvPr/>
        </p:nvSpPr>
        <p:spPr>
          <a:xfrm rot="16200000">
            <a:off x="-98066" y="4929184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Vehicle</a:t>
            </a:r>
            <a:endParaRPr lang="zh-CN" altLang="en-US" sz="1400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-98067" y="5898327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TNF-α</a:t>
            </a:r>
            <a:endParaRPr lang="zh-CN" alt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569150" y="4282522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>
                <a:solidFill>
                  <a:srgbClr val="FF0000"/>
                </a:solidFill>
              </a:rPr>
              <a:t>CD206</a:t>
            </a:r>
            <a:endParaRPr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612663" y="4271299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>
                <a:solidFill>
                  <a:srgbClr val="00B050"/>
                </a:solidFill>
              </a:rPr>
              <a:t>α-SMA</a:t>
            </a:r>
            <a:endParaRPr lang="zh-CN" altLang="en-US" sz="1400" dirty="0">
              <a:solidFill>
                <a:srgbClr val="00B050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746314" y="4282522"/>
            <a:ext cx="613363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>
                <a:solidFill>
                  <a:srgbClr val="0000FF"/>
                </a:solidFill>
              </a:rPr>
              <a:t>DAPI</a:t>
            </a:r>
            <a:endParaRPr lang="zh-CN" altLang="en-US" sz="1400" dirty="0">
              <a:solidFill>
                <a:srgbClr val="0000FF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738225" y="4282522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Merge</a:t>
            </a:r>
            <a:endParaRPr lang="zh-CN" altLang="en-US" sz="1400" dirty="0"/>
          </a:p>
        </p:txBody>
      </p:sp>
      <p:sp>
        <p:nvSpPr>
          <p:cNvPr id="44" name="TextBox 43"/>
          <p:cNvSpPr txBox="1"/>
          <p:nvPr/>
        </p:nvSpPr>
        <p:spPr>
          <a:xfrm>
            <a:off x="5616699" y="3744465"/>
            <a:ext cx="4320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pic>
        <p:nvPicPr>
          <p:cNvPr id="45" name="Picture 6" descr="C:\Users\Administrator\Desktop\2022省自然\Image 52\Image 52_c3.tif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4135" y="4540064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7" descr="C:\Users\Administrator\Desktop\2022省自然\Image 52\Image 52_c1.tif"/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9857" y="4540064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7" name="Picture 8" descr="C:\Users\Administrator\Desktop\2022省自然\Image 52\Image 52_c1+2+3.tif"/>
          <p:cNvPicPr>
            <a:picLocks noChangeAspect="1" noChangeArrowheads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93914" y="4540064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Picture 9" descr="C:\Users\Administrator\Desktop\2022省自然\Image 52\Image 52_c2.tif"/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2862" y="454234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9" name="Picture 10" descr="C:\Users\Administrator\Desktop\2022省自然\Image 63\Image 63_c3.tif"/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4135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0" name="Picture 11" descr="C:\Users\Administrator\Desktop\2022省自然\Image 63\Image 63_c1.tif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9857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Picture 12" descr="C:\Users\Administrator\Desktop\2022省自然\Image 63\Image 63_c1+2+3.tif"/>
          <p:cNvPicPr>
            <a:picLocks noChangeAspect="1" noChangeArrowheads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30000" contras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93914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13" descr="C:\Users\Administrator\Desktop\2022省自然\Image 63\Image 63_c2.tif"/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42862" y="5616786"/>
            <a:ext cx="1008000" cy="100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TextBox 52"/>
          <p:cNvSpPr txBox="1"/>
          <p:nvPr/>
        </p:nvSpPr>
        <p:spPr>
          <a:xfrm rot="16200000">
            <a:off x="5692933" y="4881236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Vehicle</a:t>
            </a:r>
            <a:endParaRPr lang="zh-CN" altLang="en-US" sz="1400" dirty="0"/>
          </a:p>
        </p:txBody>
      </p:sp>
      <p:sp>
        <p:nvSpPr>
          <p:cNvPr id="54" name="TextBox 53"/>
          <p:cNvSpPr txBox="1"/>
          <p:nvPr/>
        </p:nvSpPr>
        <p:spPr>
          <a:xfrm rot="16200000">
            <a:off x="5692934" y="5921076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TNF-α</a:t>
            </a:r>
            <a:endParaRPr lang="zh-CN" altLang="en-US" sz="1400" dirty="0"/>
          </a:p>
        </p:txBody>
      </p:sp>
      <p:sp>
        <p:nvSpPr>
          <p:cNvPr id="55" name="TextBox 54"/>
          <p:cNvSpPr txBox="1"/>
          <p:nvPr/>
        </p:nvSpPr>
        <p:spPr>
          <a:xfrm>
            <a:off x="6374833" y="4232293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 smtClean="0">
                <a:solidFill>
                  <a:srgbClr val="FF0000"/>
                </a:solidFill>
              </a:rPr>
              <a:t>F4/80</a:t>
            </a:r>
            <a:endParaRPr lang="zh-CN" altLang="en-US" sz="1400" dirty="0">
              <a:solidFill>
                <a:srgbClr val="FF0000"/>
              </a:solidFill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376308" y="4223352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>
                <a:solidFill>
                  <a:srgbClr val="00B050"/>
                </a:solidFill>
              </a:rPr>
              <a:t>α-SMA</a:t>
            </a:r>
            <a:endParaRPr lang="zh-CN" altLang="en-US" sz="1400" dirty="0">
              <a:solidFill>
                <a:srgbClr val="00B050"/>
              </a:solidFill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8541453" y="4238021"/>
            <a:ext cx="613363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>
                <a:solidFill>
                  <a:srgbClr val="0000FF"/>
                </a:solidFill>
              </a:rPr>
              <a:t>DAPI</a:t>
            </a:r>
            <a:endParaRPr lang="zh-CN" altLang="en-US" sz="1400" dirty="0">
              <a:solidFill>
                <a:srgbClr val="0000FF"/>
              </a:solidFill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9501870" y="4223351"/>
            <a:ext cx="792088" cy="307771"/>
          </a:xfrm>
          <a:prstGeom prst="rect">
            <a:avLst/>
          </a:prstGeom>
          <a:noFill/>
        </p:spPr>
        <p:txBody>
          <a:bodyPr wrap="square" lIns="91435" tIns="45717" rIns="91435" bIns="45717" rtlCol="0">
            <a:spAutoFit/>
          </a:bodyPr>
          <a:lstStyle/>
          <a:p>
            <a:r>
              <a:rPr lang="en-US" altLang="zh-CN" sz="1400" dirty="0"/>
              <a:t>Merge</a:t>
            </a:r>
            <a:endParaRPr lang="zh-CN" altLang="en-US" sz="1400" dirty="0"/>
          </a:p>
        </p:txBody>
      </p:sp>
      <p:cxnSp>
        <p:nvCxnSpPr>
          <p:cNvPr id="59" name="Straight Connector 37"/>
          <p:cNvCxnSpPr/>
          <p:nvPr/>
        </p:nvCxnSpPr>
        <p:spPr>
          <a:xfrm>
            <a:off x="504131" y="5472658"/>
            <a:ext cx="252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37"/>
          <p:cNvCxnSpPr/>
          <p:nvPr/>
        </p:nvCxnSpPr>
        <p:spPr>
          <a:xfrm>
            <a:off x="6300803" y="5472658"/>
            <a:ext cx="252000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05901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7</TotalTime>
  <Words>20</Words>
  <Application>Microsoft Office PowerPoint</Application>
  <PresentationFormat>自定义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喻文强</dc:creator>
  <cp:lastModifiedBy>喻文强</cp:lastModifiedBy>
  <cp:revision>9</cp:revision>
  <dcterms:created xsi:type="dcterms:W3CDTF">2022-07-31T13:03:20Z</dcterms:created>
  <dcterms:modified xsi:type="dcterms:W3CDTF">2022-08-13T04:23:04Z</dcterms:modified>
</cp:coreProperties>
</file>